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  <p:sldId id="262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382" autoAdjust="0"/>
    <p:restoredTop sz="94660"/>
  </p:normalViewPr>
  <p:slideViewPr>
    <p:cSldViewPr snapToGrid="0">
      <p:cViewPr varScale="1">
        <p:scale>
          <a:sx n="72" d="100"/>
          <a:sy n="72" d="100"/>
        </p:scale>
        <p:origin x="93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47586A-E489-4975-A9C0-C15AB5E3E4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>
            <a:extLst>
              <a:ext uri="{FF2B5EF4-FFF2-40B4-BE49-F238E27FC236}">
                <a16:creationId xmlns:a16="http://schemas.microsoft.com/office/drawing/2014/main" id="{97BD28C4-9E4C-45AB-8610-0EFB161DD7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F28D86-81CA-478F-8951-4A22131D2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E5A0E59-6FAB-4B3F-931F-4E422F55C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DB3222-3C23-403E-9927-9CBDCF463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8152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7BB33D-7A61-41E2-A27C-4E0FE05B1D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4AFA147-9644-4713-B88B-FB0992CF77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7FFD1F-0248-426C-A647-C135BAD41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861D3F-0DEE-429C-951F-94D7384EA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8FE750-BE09-4121-8E27-E8DE105E5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3727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C16510A-98D6-4546-8B24-92084E64FF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941EFF8-0E76-46BC-AC51-64E0DD19A3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E5672F-78B1-48D4-8E66-B906B4F945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BB768C-7DD0-4D23-8D24-7C913AB0F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D517A7-7095-45FD-9EE7-A18C1E20E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783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7EE49E-A931-4538-B7A0-940C0A27C2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78EE69F-6402-45BC-A179-68464E5D4E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B1F829-28EC-40D2-A7D3-4C7919EFB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E949DE-C8BD-4D7C-AD91-DC4E13949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6A3FC77-04AD-4897-A01B-93C2797CD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511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C87E83-7AD0-4DA2-9C2E-B58289FFA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C579181-2883-4614-8176-A3406AEEEE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64EF18-162F-4626-B377-ED8D2F52C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47921B-AAD6-4669-8660-E7A2B2F58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552E8A-32D1-4C58-8662-A311BBD1A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483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B08253-4B2E-4670-916B-EE163A705E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C0777D7-BEC2-41FC-95EF-D858FD0349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6A605B-96B4-4275-B52F-1357EA9B5C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0F06C91-1B4A-486C-BD21-26865857E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EFA54E9-18EA-4A0B-9FE4-052B33438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7BEC73-EF4E-4B6F-B64C-2911370C6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7172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EE5305-8189-4FEA-B64B-E2F57CA87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228D466-B475-47FC-8ADF-AE08F34243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14DA8F-E1FA-4630-B818-8367A4CEF0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ACB34EF-65ED-4F08-A60D-E1D3AB3D5F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FEC769E-A9EB-483E-9876-8FAAC40269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8B1537D-293F-46E8-B219-C73BD641D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6A23F1E-E2DB-416E-9FA5-7F41C73D0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A764162-B5E6-4CCA-A7F8-D3417439D2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902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560975-2B49-44FA-B4B9-1E93784924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2B1E5DB-3E8A-40C5-BDFD-95E27C1B8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3747DB4-A987-4EE5-8654-E9EAFDEFC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81F6B52-4418-4AA7-9D42-389A01B60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856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DBAF845-E9B8-44A4-922C-503EB511C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E105340-BC99-45A7-BB74-76BCD736C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CD5A751-E481-4584-A227-08C430803B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644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2F2135-F8B1-4C80-90F3-A0EC1314DB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5DAD16-3B31-4165-BA79-553DD42416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3F16559-9DFF-4548-A6F6-A9CDD74F3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1A4D78C-C499-4C15-B3D5-633EA2DF2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0D49BC-40BF-4BCE-BAF3-C13EB1674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BDE8931-EFDC-474F-9860-75760AF1A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87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DE4DB3-FC33-4AFB-A234-750CABAA2B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39802D2-49EB-481F-B62F-F1A3900D10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EF2C7FB-2B53-4BC8-929E-21C8BDC6E9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FBC38C2-3320-413B-AB20-3BA11D89E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3B94B6-FAA0-41BD-B9D5-1F1865582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31B645-42F7-43D3-883A-CCDE10A5E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09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7006311-AF56-4BF4-B508-0924CD47D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37BC674-C92E-4F0C-8181-E36117ED0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04C632-A64C-4AF3-A0B8-2C0A59CAE5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2D5F1-EE90-417C-9E30-1D2D6614893F}" type="datetimeFigureOut">
              <a:rPr kumimoji="1" lang="ja-JP" altLang="en-US" smtClean="0"/>
              <a:t>2018/1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CAB084-26DE-4E38-A5F4-E0D310366E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47BA52-874F-4605-A3D0-B1FB17E1B0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342FB-9689-4EAE-ADBA-C07375BC60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553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CA28AB5-F2DB-4BF5-A5A6-DB6B4C1E15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6" t="1" r="1340" b="2791"/>
          <a:stretch/>
        </p:blipFill>
        <p:spPr>
          <a:xfrm>
            <a:off x="1404730" y="328446"/>
            <a:ext cx="7053470" cy="584813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3B2F38C-53E1-4D43-9E72-97A6C83E0ADA}"/>
              </a:ext>
            </a:extLst>
          </p:cNvPr>
          <p:cNvSpPr txBox="1"/>
          <p:nvPr/>
        </p:nvSpPr>
        <p:spPr>
          <a:xfrm>
            <a:off x="3454400" y="-40886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A1</a:t>
            </a:r>
            <a:endParaRPr kumimoji="1" lang="ja-JP" altLang="en-US" i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7E5B6E1-5216-4531-907E-6A5A5F763F06}"/>
              </a:ext>
            </a:extLst>
          </p:cNvPr>
          <p:cNvSpPr txBox="1"/>
          <p:nvPr/>
        </p:nvSpPr>
        <p:spPr>
          <a:xfrm>
            <a:off x="4133850" y="-40886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A2</a:t>
            </a:r>
            <a:endParaRPr kumimoji="1" lang="ja-JP" altLang="en-US" i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33231EA-C535-4B43-86BB-BCCB0ADFE355}"/>
              </a:ext>
            </a:extLst>
          </p:cNvPr>
          <p:cNvSpPr txBox="1"/>
          <p:nvPr/>
        </p:nvSpPr>
        <p:spPr>
          <a:xfrm>
            <a:off x="3867150" y="-40886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F</a:t>
            </a:r>
            <a:endParaRPr kumimoji="1" lang="ja-JP" altLang="en-US" i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0645E6A-6F76-4A7F-B099-77D501F66AF6}"/>
              </a:ext>
            </a:extLst>
          </p:cNvPr>
          <p:cNvSpPr txBox="1"/>
          <p:nvPr/>
        </p:nvSpPr>
        <p:spPr>
          <a:xfrm>
            <a:off x="8890000" y="520698"/>
            <a:ext cx="3302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A1: Figure 1, panel A, lane 1</a:t>
            </a:r>
          </a:p>
          <a:p>
            <a:r>
              <a:rPr kumimoji="1" lang="en-US" altLang="ja-JP" dirty="0"/>
              <a:t>A2</a:t>
            </a:r>
            <a:r>
              <a:rPr lang="en-US" altLang="ja-JP" dirty="0"/>
              <a:t>: Figure 1, panel A, lane 2</a:t>
            </a:r>
          </a:p>
          <a:p>
            <a:r>
              <a:rPr kumimoji="1" lang="en-US" altLang="ja-JP" dirty="0"/>
              <a:t>F: Figure 1, panel F</a:t>
            </a:r>
          </a:p>
          <a:p>
            <a:r>
              <a:rPr lang="en-US" altLang="ja-JP" dirty="0"/>
              <a:t>M: Molecular weight marker</a:t>
            </a:r>
            <a:endParaRPr kumimoji="1" lang="en-US" altLang="ja-JP" dirty="0"/>
          </a:p>
          <a:p>
            <a:endParaRPr kumimoji="1"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1B6F8DF-7A81-45F8-AE26-A5D49048C127}"/>
              </a:ext>
            </a:extLst>
          </p:cNvPr>
          <p:cNvSpPr txBox="1"/>
          <p:nvPr/>
        </p:nvSpPr>
        <p:spPr>
          <a:xfrm>
            <a:off x="4514850" y="-40886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M</a:t>
            </a:r>
            <a:endParaRPr kumimoji="1" lang="ja-JP" altLang="en-US" i="1" dirty="0"/>
          </a:p>
        </p:txBody>
      </p:sp>
      <p:sp>
        <p:nvSpPr>
          <p:cNvPr id="10" name="テキスト ボックス 6">
            <a:extLst>
              <a:ext uri="{FF2B5EF4-FFF2-40B4-BE49-F238E27FC236}">
                <a16:creationId xmlns:a16="http://schemas.microsoft.com/office/drawing/2014/main" id="{D414F0F8-78B2-4D22-9A88-70CD8DA55DD5}"/>
              </a:ext>
            </a:extLst>
          </p:cNvPr>
          <p:cNvSpPr txBox="1"/>
          <p:nvPr/>
        </p:nvSpPr>
        <p:spPr>
          <a:xfrm>
            <a:off x="1404730" y="6192598"/>
            <a:ext cx="94479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A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from the SDS-PAGE showed the synthesized WT-HRH1 and D107A-HRH1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1453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5A79BB1-ADD6-4DA9-AFF8-0FCD90DA3E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95" t="6154" r="5820" b="-7578"/>
          <a:stretch/>
        </p:blipFill>
        <p:spPr>
          <a:xfrm>
            <a:off x="1770743" y="725714"/>
            <a:ext cx="1756228" cy="394132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4075BF4-3F6C-4265-B261-59B585D0E8C1}"/>
              </a:ext>
            </a:extLst>
          </p:cNvPr>
          <p:cNvSpPr txBox="1"/>
          <p:nvPr/>
        </p:nvSpPr>
        <p:spPr>
          <a:xfrm>
            <a:off x="2496457" y="356382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B</a:t>
            </a:r>
            <a:endParaRPr kumimoji="1" lang="ja-JP" altLang="en-US" i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49EAD5C-2E3F-4350-A520-44C6F2CD1C8D}"/>
              </a:ext>
            </a:extLst>
          </p:cNvPr>
          <p:cNvSpPr txBox="1"/>
          <p:nvPr/>
        </p:nvSpPr>
        <p:spPr>
          <a:xfrm>
            <a:off x="3768271" y="725714"/>
            <a:ext cx="330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B: Figure 1, panel B</a:t>
            </a:r>
          </a:p>
          <a:p>
            <a:r>
              <a:rPr lang="en-US" altLang="ja-JP" dirty="0"/>
              <a:t>M: Molecular weight marker</a:t>
            </a:r>
            <a:endParaRPr kumimoji="1" lang="en-US" altLang="ja-JP" dirty="0"/>
          </a:p>
          <a:p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0148BF6-BA2F-4D09-ABE5-5D0D6AAE9220}"/>
              </a:ext>
            </a:extLst>
          </p:cNvPr>
          <p:cNvSpPr txBox="1"/>
          <p:nvPr/>
        </p:nvSpPr>
        <p:spPr>
          <a:xfrm>
            <a:off x="2217964" y="356382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M</a:t>
            </a:r>
            <a:endParaRPr kumimoji="1" lang="ja-JP" altLang="en-US" i="1" dirty="0"/>
          </a:p>
        </p:txBody>
      </p:sp>
      <p:sp>
        <p:nvSpPr>
          <p:cNvPr id="9" name="テキスト ボックス 6">
            <a:extLst>
              <a:ext uri="{FF2B5EF4-FFF2-40B4-BE49-F238E27FC236}">
                <a16:creationId xmlns:a16="http://schemas.microsoft.com/office/drawing/2014/main" id="{EDE90B94-0213-4997-9E3D-B00C6E59C85F}"/>
              </a:ext>
            </a:extLst>
          </p:cNvPr>
          <p:cNvSpPr txBox="1"/>
          <p:nvPr/>
        </p:nvSpPr>
        <p:spPr>
          <a:xfrm>
            <a:off x="940904" y="4522824"/>
            <a:ext cx="94479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B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from the autoradiography showed the synthesized [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-HRH1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5463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548797B-DF63-43AD-83F5-7B9CE8E104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6" t="974" r="-315" b="-177"/>
          <a:stretch/>
        </p:blipFill>
        <p:spPr>
          <a:xfrm>
            <a:off x="1074056" y="769256"/>
            <a:ext cx="6251117" cy="528320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EA253C2-135A-4A5B-91D1-A96963FE24A0}"/>
              </a:ext>
            </a:extLst>
          </p:cNvPr>
          <p:cNvSpPr txBox="1"/>
          <p:nvPr/>
        </p:nvSpPr>
        <p:spPr>
          <a:xfrm>
            <a:off x="4934857" y="399924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C</a:t>
            </a:r>
            <a:r>
              <a:rPr kumimoji="1" lang="en-US" altLang="ja-JP" i="1" dirty="0"/>
              <a:t>1</a:t>
            </a:r>
            <a:endParaRPr kumimoji="1" lang="ja-JP" altLang="en-US" i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D7A8881-C14D-49BA-A5AC-10A3CC46B883}"/>
              </a:ext>
            </a:extLst>
          </p:cNvPr>
          <p:cNvSpPr txBox="1"/>
          <p:nvPr/>
        </p:nvSpPr>
        <p:spPr>
          <a:xfrm>
            <a:off x="5347607" y="399924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C2</a:t>
            </a:r>
            <a:endParaRPr kumimoji="1" lang="ja-JP" altLang="en-US" i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A88AB13-817C-4CAE-8E52-FAC8B27F2586}"/>
              </a:ext>
            </a:extLst>
          </p:cNvPr>
          <p:cNvSpPr txBox="1"/>
          <p:nvPr/>
        </p:nvSpPr>
        <p:spPr>
          <a:xfrm>
            <a:off x="1408793" y="407183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M</a:t>
            </a:r>
            <a:endParaRPr kumimoji="1" lang="ja-JP" altLang="en-US" i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56523FC-F90F-4E63-BC85-0F7F7A92A182}"/>
              </a:ext>
            </a:extLst>
          </p:cNvPr>
          <p:cNvSpPr txBox="1"/>
          <p:nvPr/>
        </p:nvSpPr>
        <p:spPr>
          <a:xfrm>
            <a:off x="5726790" y="407183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C3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22E7260-72F7-4119-B784-53A05B9E9515}"/>
              </a:ext>
            </a:extLst>
          </p:cNvPr>
          <p:cNvSpPr txBox="1"/>
          <p:nvPr/>
        </p:nvSpPr>
        <p:spPr>
          <a:xfrm>
            <a:off x="7659910" y="776515"/>
            <a:ext cx="33020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C1: Figure 1, panel C, lane 1</a:t>
            </a:r>
          </a:p>
          <a:p>
            <a:r>
              <a:rPr lang="en-US" altLang="ja-JP" dirty="0"/>
              <a:t>       (Liposome)</a:t>
            </a:r>
          </a:p>
          <a:p>
            <a:r>
              <a:rPr lang="en-US" altLang="ja-JP" dirty="0"/>
              <a:t>C</a:t>
            </a:r>
            <a:r>
              <a:rPr kumimoji="1" lang="en-US" altLang="ja-JP" dirty="0"/>
              <a:t>2</a:t>
            </a:r>
            <a:r>
              <a:rPr lang="en-US" altLang="ja-JP" dirty="0"/>
              <a:t>: Figure 1, panel C, lane 2</a:t>
            </a:r>
          </a:p>
          <a:p>
            <a:r>
              <a:rPr lang="en-US" altLang="ja-JP" dirty="0"/>
              <a:t>       (10% </a:t>
            </a:r>
            <a:r>
              <a:rPr lang="en-US" altLang="ja-JP" dirty="0" err="1"/>
              <a:t>Glycerosome</a:t>
            </a:r>
            <a:r>
              <a:rPr lang="en-US" altLang="ja-JP" dirty="0"/>
              <a:t>)</a:t>
            </a:r>
          </a:p>
          <a:p>
            <a:r>
              <a:rPr lang="en-US" altLang="ja-JP" dirty="0"/>
              <a:t>C3: Figure 1, panel C, lane 3</a:t>
            </a:r>
          </a:p>
          <a:p>
            <a:r>
              <a:rPr lang="en-US" altLang="ja-JP" dirty="0"/>
              <a:t>       (20% </a:t>
            </a:r>
            <a:r>
              <a:rPr lang="en-US" altLang="ja-JP" dirty="0" err="1"/>
              <a:t>Glycerosome</a:t>
            </a:r>
            <a:r>
              <a:rPr lang="en-US" altLang="ja-JP" dirty="0"/>
              <a:t>)</a:t>
            </a:r>
          </a:p>
          <a:p>
            <a:r>
              <a:rPr lang="en-US" altLang="ja-JP" dirty="0"/>
              <a:t>M: Molecular weight marker</a:t>
            </a:r>
            <a:endParaRPr kumimoji="1" lang="en-US" altLang="ja-JP" dirty="0"/>
          </a:p>
          <a:p>
            <a:endParaRPr kumimoji="1" lang="ja-JP" altLang="en-US" dirty="0"/>
          </a:p>
        </p:txBody>
      </p:sp>
      <p:sp>
        <p:nvSpPr>
          <p:cNvPr id="10" name="テキスト ボックス 6">
            <a:extLst>
              <a:ext uri="{FF2B5EF4-FFF2-40B4-BE49-F238E27FC236}">
                <a16:creationId xmlns:a16="http://schemas.microsoft.com/office/drawing/2014/main" id="{4377615D-9919-4597-9591-45D4ABFBA28A}"/>
              </a:ext>
            </a:extLst>
          </p:cNvPr>
          <p:cNvSpPr txBox="1"/>
          <p:nvPr/>
        </p:nvSpPr>
        <p:spPr>
          <a:xfrm>
            <a:off x="896671" y="6211669"/>
            <a:ext cx="94479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C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from the SDS-PAGE showed the synthesized WT-HRH1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bined with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olecti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osome, 10%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20%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1907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02A9B78-19C7-4477-BD9A-A7DA46D443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" t="2406" r="-308"/>
          <a:stretch/>
        </p:blipFill>
        <p:spPr>
          <a:xfrm>
            <a:off x="1393370" y="711199"/>
            <a:ext cx="6110515" cy="5397438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AD941DE-D5CC-4C2D-ABD5-51025799153E}"/>
              </a:ext>
            </a:extLst>
          </p:cNvPr>
          <p:cNvSpPr txBox="1"/>
          <p:nvPr/>
        </p:nvSpPr>
        <p:spPr>
          <a:xfrm>
            <a:off x="3120573" y="399924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D</a:t>
            </a:r>
            <a:r>
              <a:rPr kumimoji="1" lang="en-US" altLang="ja-JP" i="1" dirty="0"/>
              <a:t>1</a:t>
            </a:r>
            <a:endParaRPr kumimoji="1" lang="ja-JP" altLang="en-US" i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468532A-8E5A-46B6-8E0C-9A0071A17666}"/>
              </a:ext>
            </a:extLst>
          </p:cNvPr>
          <p:cNvSpPr txBox="1"/>
          <p:nvPr/>
        </p:nvSpPr>
        <p:spPr>
          <a:xfrm>
            <a:off x="4404181" y="399924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D2</a:t>
            </a:r>
            <a:endParaRPr kumimoji="1" lang="ja-JP" altLang="en-US" i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0F2C52B-F008-4D28-B01F-C2CB33330EA5}"/>
              </a:ext>
            </a:extLst>
          </p:cNvPr>
          <p:cNvSpPr txBox="1"/>
          <p:nvPr/>
        </p:nvSpPr>
        <p:spPr>
          <a:xfrm>
            <a:off x="1844218" y="407183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i="1" dirty="0"/>
              <a:t>M</a:t>
            </a:r>
            <a:endParaRPr kumimoji="1" lang="ja-JP" altLang="en-US" i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BFF6C8-077F-47DB-B14D-4CE14BB2E02C}"/>
              </a:ext>
            </a:extLst>
          </p:cNvPr>
          <p:cNvSpPr txBox="1"/>
          <p:nvPr/>
        </p:nvSpPr>
        <p:spPr>
          <a:xfrm>
            <a:off x="5726790" y="407183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D3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CEB1EBB-7F74-40A7-A030-2E22AC6896D4}"/>
              </a:ext>
            </a:extLst>
          </p:cNvPr>
          <p:cNvSpPr txBox="1"/>
          <p:nvPr/>
        </p:nvSpPr>
        <p:spPr>
          <a:xfrm>
            <a:off x="7659910" y="776515"/>
            <a:ext cx="33020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D1: Figure 1, panel D, lane 1</a:t>
            </a:r>
          </a:p>
          <a:p>
            <a:r>
              <a:rPr lang="en-US" altLang="ja-JP" dirty="0"/>
              <a:t>      (21,400 × </a:t>
            </a:r>
            <a:r>
              <a:rPr lang="en-US" altLang="ja-JP" i="1" dirty="0"/>
              <a:t>g</a:t>
            </a:r>
            <a:r>
              <a:rPr lang="en-US" altLang="ja-JP" dirty="0"/>
              <a:t>)</a:t>
            </a:r>
          </a:p>
          <a:p>
            <a:r>
              <a:rPr lang="en-US" altLang="ja-JP" dirty="0"/>
              <a:t>D</a:t>
            </a:r>
            <a:r>
              <a:rPr kumimoji="1" lang="en-US" altLang="ja-JP" dirty="0"/>
              <a:t>2</a:t>
            </a:r>
            <a:r>
              <a:rPr lang="en-US" altLang="ja-JP" dirty="0"/>
              <a:t>: Figure 1, panel D, lane 2</a:t>
            </a:r>
          </a:p>
          <a:p>
            <a:r>
              <a:rPr lang="en-US" altLang="ja-JP" dirty="0"/>
              <a:t>      (50,000 × </a:t>
            </a:r>
            <a:r>
              <a:rPr lang="en-US" altLang="ja-JP" i="1" dirty="0"/>
              <a:t>g</a:t>
            </a:r>
            <a:r>
              <a:rPr lang="en-US" altLang="ja-JP" dirty="0"/>
              <a:t>)</a:t>
            </a:r>
          </a:p>
          <a:p>
            <a:r>
              <a:rPr lang="en-US" altLang="ja-JP" dirty="0"/>
              <a:t>D3: Figure 1, panel D, lane 3</a:t>
            </a:r>
          </a:p>
          <a:p>
            <a:r>
              <a:rPr lang="en-US" altLang="ja-JP" dirty="0"/>
              <a:t>      (100,000 × </a:t>
            </a:r>
            <a:r>
              <a:rPr lang="en-US" altLang="ja-JP" i="1" dirty="0"/>
              <a:t>g</a:t>
            </a:r>
            <a:r>
              <a:rPr lang="en-US" altLang="ja-JP" dirty="0"/>
              <a:t>)</a:t>
            </a:r>
          </a:p>
          <a:p>
            <a:r>
              <a:rPr lang="en-US" altLang="ja-JP" dirty="0"/>
              <a:t>M: Molecular weight marker</a:t>
            </a:r>
            <a:endParaRPr kumimoji="1" lang="en-US" altLang="ja-JP" dirty="0"/>
          </a:p>
          <a:p>
            <a:endParaRPr kumimoji="1" lang="ja-JP" altLang="en-US" dirty="0"/>
          </a:p>
        </p:txBody>
      </p:sp>
      <p:sp>
        <p:nvSpPr>
          <p:cNvPr id="11" name="テキスト ボックス 6">
            <a:extLst>
              <a:ext uri="{FF2B5EF4-FFF2-40B4-BE49-F238E27FC236}">
                <a16:creationId xmlns:a16="http://schemas.microsoft.com/office/drawing/2014/main" id="{5B60CC41-AF02-45E9-974C-C559579713D9}"/>
              </a:ext>
            </a:extLst>
          </p:cNvPr>
          <p:cNvSpPr txBox="1"/>
          <p:nvPr/>
        </p:nvSpPr>
        <p:spPr>
          <a:xfrm>
            <a:off x="1015939" y="6185165"/>
            <a:ext cx="94479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D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from the SDS-PAGE showed the synthesized WT-HRH1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glycerosome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ich were purified by different centrifugation speed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00097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EA04A66-8E34-4125-B8FF-567BBED85B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8922" y="786033"/>
            <a:ext cx="7551295" cy="503419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4FDFBD3-4471-4DC2-8815-6CDEC537806C}"/>
              </a:ext>
            </a:extLst>
          </p:cNvPr>
          <p:cNvSpPr txBox="1"/>
          <p:nvPr/>
        </p:nvSpPr>
        <p:spPr>
          <a:xfrm>
            <a:off x="4512008" y="431215"/>
            <a:ext cx="546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/>
              <a:t>E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B97074A-ABCC-4E67-9E1A-A729EA4E33A7}"/>
              </a:ext>
            </a:extLst>
          </p:cNvPr>
          <p:cNvSpPr txBox="1"/>
          <p:nvPr/>
        </p:nvSpPr>
        <p:spPr>
          <a:xfrm>
            <a:off x="8790217" y="965201"/>
            <a:ext cx="330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E: Figure 1, panel E</a:t>
            </a:r>
            <a:endParaRPr kumimoji="1" lang="ja-JP" altLang="en-US" dirty="0"/>
          </a:p>
        </p:txBody>
      </p:sp>
      <p:sp>
        <p:nvSpPr>
          <p:cNvPr id="8" name="テキスト ボックス 6">
            <a:extLst>
              <a:ext uri="{FF2B5EF4-FFF2-40B4-BE49-F238E27FC236}">
                <a16:creationId xmlns:a16="http://schemas.microsoft.com/office/drawing/2014/main" id="{B1B180FF-942C-496E-8044-082E3EC58543}"/>
              </a:ext>
            </a:extLst>
          </p:cNvPr>
          <p:cNvSpPr txBox="1"/>
          <p:nvPr/>
        </p:nvSpPr>
        <p:spPr>
          <a:xfrm>
            <a:off x="993246" y="5922355"/>
            <a:ext cx="77969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E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image from the western blot of synthesized WT-HRH1 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glycerosomes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074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76</TotalTime>
  <Words>267</Words>
  <Application>Microsoft Office PowerPoint</Application>
  <PresentationFormat>ワイド画面</PresentationFormat>
  <Paragraphs>41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康之</dc:creator>
  <cp:lastModifiedBy>鈴木康之</cp:lastModifiedBy>
  <cp:revision>42</cp:revision>
  <dcterms:created xsi:type="dcterms:W3CDTF">2017-08-22T19:34:21Z</dcterms:created>
  <dcterms:modified xsi:type="dcterms:W3CDTF">2018-01-23T07:41:10Z</dcterms:modified>
</cp:coreProperties>
</file>